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10058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907D81-D8F6-4B47-8BBA-F1BB5E8D76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402840"/>
            <a:ext cx="82296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2346120"/>
            <a:ext cx="82296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5814000"/>
            <a:ext cx="82296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74828-FCAD-42F5-9EF4-18CAFABBEE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402840"/>
            <a:ext cx="82296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2346120"/>
            <a:ext cx="4015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2346120"/>
            <a:ext cx="4015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5814000"/>
            <a:ext cx="4015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5814000"/>
            <a:ext cx="4015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8146D9-CA67-405A-A5DC-9CA74CDD09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402840"/>
            <a:ext cx="82296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2346120"/>
            <a:ext cx="26496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2346120"/>
            <a:ext cx="26496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2346120"/>
            <a:ext cx="26496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5814000"/>
            <a:ext cx="26496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5814000"/>
            <a:ext cx="26496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5814000"/>
            <a:ext cx="26496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5D5A9B-1371-469B-8F27-40EDC5CF31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402840"/>
            <a:ext cx="82296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2346120"/>
            <a:ext cx="8229600" cy="6638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C64810-6E8F-46B9-9337-3D72A94E98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402840"/>
            <a:ext cx="82296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2346120"/>
            <a:ext cx="822960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692B87-8405-41FA-B1D5-B7488A037B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402840"/>
            <a:ext cx="82296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2346120"/>
            <a:ext cx="401580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2346120"/>
            <a:ext cx="401580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46031E-899D-42C0-9210-5610348371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402840"/>
            <a:ext cx="82296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9D5E91-9751-4B8E-8B30-2415CA15A0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402840"/>
            <a:ext cx="8229600" cy="7772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C6B7B5-EE8B-4A6C-83EB-2C74F93AC5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402840"/>
            <a:ext cx="82296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2346120"/>
            <a:ext cx="4015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2346120"/>
            <a:ext cx="401580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5814000"/>
            <a:ext cx="4015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94F231-F0C8-4F72-9BC8-037D104782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402840"/>
            <a:ext cx="82296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2346120"/>
            <a:ext cx="401580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2346120"/>
            <a:ext cx="4015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5814000"/>
            <a:ext cx="4015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6D43F1-6B30-43D2-AEE8-3D9240DDBB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402840"/>
            <a:ext cx="82296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2346120"/>
            <a:ext cx="4015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2346120"/>
            <a:ext cx="4015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5814000"/>
            <a:ext cx="82296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258BA-6CCD-46FB-ADA2-46315DB159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402840"/>
            <a:ext cx="82296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2346120"/>
            <a:ext cx="822960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9323280"/>
            <a:ext cx="213372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9323280"/>
            <a:ext cx="289584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9323280"/>
            <a:ext cx="213372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0C2F8C2-991F-420B-8569-AB3272EC3C1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1722240" y="6300720"/>
            <a:ext cx="1273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NF5/SNF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5"/>
          <p:cNvSpPr/>
          <p:nvPr/>
        </p:nvSpPr>
        <p:spPr>
          <a:xfrm>
            <a:off x="3390480" y="6300720"/>
            <a:ext cx="89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l-GR" sz="1600" spc="-1" strike="noStrike">
                <a:solidFill>
                  <a:srgbClr val="000000"/>
                </a:solidFill>
                <a:latin typeface="Arial"/>
                <a:ea typeface="Arial"/>
              </a:rPr>
              <a:t>snf5Δ/Δ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ctangle 6"/>
          <p:cNvSpPr/>
          <p:nvPr/>
        </p:nvSpPr>
        <p:spPr>
          <a:xfrm>
            <a:off x="4840560" y="6300720"/>
            <a:ext cx="9867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nf5Δ/Δ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+ pSNF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7"/>
          <p:cNvSpPr/>
          <p:nvPr/>
        </p:nvSpPr>
        <p:spPr>
          <a:xfrm>
            <a:off x="6071400" y="6300720"/>
            <a:ext cx="12459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nf5Δ/Δ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+ ACE2-O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7"/>
          <p:cNvSpPr/>
          <p:nvPr/>
        </p:nvSpPr>
        <p:spPr>
          <a:xfrm rot="16200000">
            <a:off x="-199440" y="3189240"/>
            <a:ext cx="270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Relative expression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6" name="Group 1"/>
          <p:cNvGrpSpPr/>
          <p:nvPr/>
        </p:nvGrpSpPr>
        <p:grpSpPr>
          <a:xfrm>
            <a:off x="1322280" y="311040"/>
            <a:ext cx="6883560" cy="5943600"/>
            <a:chOff x="1322280" y="311040"/>
            <a:chExt cx="6883560" cy="5943600"/>
          </a:xfrm>
        </p:grpSpPr>
        <p:pic>
          <p:nvPicPr>
            <p:cNvPr id="47" name="Picture 3" descr="snf5ace2oertpcr.tiff"/>
            <p:cNvPicPr/>
            <p:nvPr/>
          </p:nvPicPr>
          <p:blipFill>
            <a:blip r:embed="rId1"/>
            <a:srcRect l="1080" t="2188" r="30360" b="1592"/>
            <a:stretch/>
          </p:blipFill>
          <p:spPr>
            <a:xfrm>
              <a:off x="1322280" y="311040"/>
              <a:ext cx="6218640" cy="594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3" descr="snf5ace2oertpcr.tiff"/>
            <p:cNvPicPr/>
            <p:nvPr/>
          </p:nvPicPr>
          <p:blipFill>
            <a:blip r:embed="rId2"/>
            <a:srcRect l="86229" t="2188" r="6442" b="1592"/>
            <a:stretch/>
          </p:blipFill>
          <p:spPr>
            <a:xfrm>
              <a:off x="7540920" y="311040"/>
              <a:ext cx="664920" cy="59436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9" name="Straight Connector 20"/>
          <p:cNvSpPr/>
          <p:nvPr/>
        </p:nvSpPr>
        <p:spPr>
          <a:xfrm>
            <a:off x="3433680" y="6148440"/>
            <a:ext cx="392040" cy="0"/>
          </a:xfrm>
          <a:prstGeom prst="line">
            <a:avLst/>
          </a:prstGeom>
          <a:ln w="1260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Straight Connector 21"/>
          <p:cNvSpPr/>
          <p:nvPr/>
        </p:nvSpPr>
        <p:spPr>
          <a:xfrm>
            <a:off x="6424560" y="6148440"/>
            <a:ext cx="392040" cy="0"/>
          </a:xfrm>
          <a:prstGeom prst="line">
            <a:avLst/>
          </a:prstGeom>
          <a:ln w="1260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"/>
          <p:cNvSpPr/>
          <p:nvPr/>
        </p:nvSpPr>
        <p:spPr>
          <a:xfrm>
            <a:off x="1187280" y="7216920"/>
            <a:ext cx="701856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2.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RNA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Levels of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NF5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and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ACE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in strains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NF5/SNF5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nf5Δ/Δ, snf5Δ/Δ + pSNF5,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nd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nf5Δ/Δ + ACE2-OE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grown in YPD were determined by QrtPCR, normalized to control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DH3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RNA, with levels in the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NF5/SNF5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(wildtype) strain set as 1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04T20:54:25Z</dcterms:created>
  <dc:creator>Jonathan Finkel</dc:creator>
  <dc:description/>
  <dc:language>en-US</dc:language>
  <cp:lastModifiedBy>Aaron Mitchell</cp:lastModifiedBy>
  <dcterms:modified xsi:type="dcterms:W3CDTF">2011-10-24T17:47:02Z</dcterms:modified>
  <cp:revision>13</cp:revision>
  <dc:subject/>
  <dc:title>PowerPoint Presentation</dc:title>
</cp:coreProperties>
</file>